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1" d="100"/>
          <a:sy n="71" d="100"/>
        </p:scale>
        <p:origin x="-1356" y="-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844250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225212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33838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7947730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92045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17914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1793636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327782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15347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868200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050334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DF82A-151C-467A-B096-CB7F6C79954B}" type="datetimeFigureOut">
              <a:rPr lang="nl-BE" smtClean="0"/>
              <a:t>9/06/2016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FB2180-E293-47CC-A9B9-3E149EB7BD0D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276852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 rotWithShape="1">
          <a:blip r:embed="rId2"/>
          <a:srcRect b="49588"/>
          <a:stretch/>
        </p:blipFill>
        <p:spPr bwMode="auto">
          <a:xfrm>
            <a:off x="179512" y="988568"/>
            <a:ext cx="8784976" cy="473861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Rectangle 4"/>
          <p:cNvSpPr/>
          <p:nvPr/>
        </p:nvSpPr>
        <p:spPr>
          <a:xfrm>
            <a:off x="179512" y="242064"/>
            <a:ext cx="864096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Figure S2</a:t>
            </a:r>
            <a:r>
              <a:rPr lang="en-US" sz="1400" dirty="0"/>
              <a:t>. Minimum-spanning tree analysis of MLVA (multiple-locus variable-number tandem-repeats analysis) data of 56 </a:t>
            </a:r>
            <a:r>
              <a:rPr lang="en-US" sz="1400" i="1" dirty="0"/>
              <a:t>Salmonella </a:t>
            </a:r>
            <a:r>
              <a:rPr lang="en-US" sz="1400" dirty="0"/>
              <a:t>Enteritidis isolates from the Oriental Province, DRC, 2009-2004. Each circle displays a unique MLVA type, with different </a:t>
            </a:r>
            <a:r>
              <a:rPr lang="en-GB" sz="1400" dirty="0"/>
              <a:t>colours</a:t>
            </a:r>
            <a:r>
              <a:rPr lang="en-US" sz="1400" dirty="0"/>
              <a:t> indicating the year of collection of isolates. </a:t>
            </a:r>
            <a:endParaRPr lang="nl-BE" sz="1400" dirty="0"/>
          </a:p>
        </p:txBody>
      </p:sp>
      <p:pic>
        <p:nvPicPr>
          <p:cNvPr id="7" name="Picture 6"/>
          <p:cNvPicPr/>
          <p:nvPr/>
        </p:nvPicPr>
        <p:blipFill>
          <a:blip r:embed="rId3"/>
          <a:stretch>
            <a:fillRect/>
          </a:stretch>
        </p:blipFill>
        <p:spPr>
          <a:xfrm>
            <a:off x="7452320" y="5068543"/>
            <a:ext cx="1152128" cy="13172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6295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67</TotalTime>
  <Words>4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T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Kuijpers</dc:creator>
  <cp:lastModifiedBy>Laura Kuijpers</cp:lastModifiedBy>
  <cp:revision>4</cp:revision>
  <dcterms:created xsi:type="dcterms:W3CDTF">2016-05-22T18:59:45Z</dcterms:created>
  <dcterms:modified xsi:type="dcterms:W3CDTF">2016-06-09T21:13:43Z</dcterms:modified>
</cp:coreProperties>
</file>